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633" r:id="rId2"/>
  </p:sldIdLst>
  <p:sldSz cx="9144000" cy="6858000" type="screen4x3"/>
  <p:notesSz cx="6807200" cy="99393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Calibri" pitchFamily="34" charset="0"/>
        <a:ea typeface="ＭＳ Ｐゴシック" charset="-128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clrMru>
    <a:srgbClr val="FFEBFA"/>
    <a:srgbClr val="FFFFCC"/>
    <a:srgbClr val="CCFFFF"/>
    <a:srgbClr val="0066FF"/>
    <a:srgbClr val="FFCCFF"/>
    <a:srgbClr val="FF99FF"/>
    <a:srgbClr val="FF00FF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9CF1AB2-1976-4502-BF36-3FF5EA218861}" styleName="中間スタイル 4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F5AB1C69-6EDB-4FF4-983F-18BD219EF322}" styleName="中間スタイル 2 - アクセント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5" autoAdjust="0"/>
    <p:restoredTop sz="85696" autoAdjust="0"/>
  </p:normalViewPr>
  <p:slideViewPr>
    <p:cSldViewPr>
      <p:cViewPr varScale="1">
        <p:scale>
          <a:sx n="106" d="100"/>
          <a:sy n="106" d="100"/>
        </p:scale>
        <p:origin x="-186" y="-10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8472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-7085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50263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350" y="1"/>
            <a:ext cx="2950263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>
              <a:defRPr sz="1200"/>
            </a:lvl1pPr>
          </a:lstStyle>
          <a:p>
            <a:fld id="{4E9AE27A-DF6D-4562-99CC-4BABF7E8CEF1}" type="datetimeFigureOut">
              <a:rPr kumimoji="1" lang="ja-JP" altLang="en-US" smtClean="0"/>
              <a:pPr/>
              <a:t>2018/10/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1" y="9440864"/>
            <a:ext cx="2950263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350" y="9440864"/>
            <a:ext cx="2950263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>
              <a:defRPr sz="1200"/>
            </a:lvl1pPr>
          </a:lstStyle>
          <a:p>
            <a:fld id="{005DA3CA-9C3E-45CA-B152-1DAE3EBE1B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20656966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950263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350" y="1"/>
            <a:ext cx="2950263" cy="496888"/>
          </a:xfrm>
          <a:prstGeom prst="rect">
            <a:avLst/>
          </a:prstGeom>
        </p:spPr>
        <p:txBody>
          <a:bodyPr vert="horz" lIns="91435" tIns="45717" rIns="91435" bIns="45717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CF9B4F58-69A7-48F8-9860-DF728197F971}" type="datetimeFigureOut">
              <a:rPr lang="ja-JP" altLang="en-US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20750" y="746125"/>
            <a:ext cx="4968875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7" rIns="91435" bIns="45717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1198" y="4721225"/>
            <a:ext cx="5444806" cy="4471988"/>
          </a:xfrm>
          <a:prstGeom prst="rect">
            <a:avLst/>
          </a:prstGeom>
        </p:spPr>
        <p:txBody>
          <a:bodyPr vert="horz" lIns="91435" tIns="45717" rIns="91435" bIns="45717" rtlCol="0"/>
          <a:lstStyle/>
          <a:p>
            <a:pPr lvl="0"/>
            <a:r>
              <a:rPr lang="ja-JP" altLang="en-US" noProof="0" smtClean="0"/>
              <a:t>マスター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440864"/>
            <a:ext cx="2950263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350" y="9440864"/>
            <a:ext cx="2950263" cy="496887"/>
          </a:xfrm>
          <a:prstGeom prst="rect">
            <a:avLst/>
          </a:prstGeom>
        </p:spPr>
        <p:txBody>
          <a:bodyPr vert="horz" lIns="91435" tIns="45717" rIns="91435" bIns="45717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fld id="{7F45E0DF-98F8-4187-9885-FD2AF3F0B08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87976117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6451C0-01CB-4D47-904C-D7AEDA33628F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7E3D6C-AA5B-4084-B4D0-DEE30A48450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5681971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5D6D232-E232-4691-9642-6A700907A42B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0C3EBE-967D-4D24-BCE8-106EA8FEE61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348394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CF276A-E2B9-4716-8F6E-4E43306862C9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EE17EA-0E3B-4BFF-8F3F-91E9DF674AE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6160325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85E2E1-FB86-4393-A081-A9A465BC0F8C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1E9998-F987-466C-A549-AF2B5D558B3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377364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120D3D-A9F3-4300-A381-3193E31953C6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374BF1-CD77-447A-A379-9BB5BA61D554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174660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DAD447-5159-49CC-ADC8-0483FFA1C22F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B18FDAD-8BA5-47DA-BDC6-74C8887AAA3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776856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148F82-CBB8-484D-A74A-FD7782B5D170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4E8B64-106B-48EB-905D-D7EF52075C4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3222675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25763A-A0A3-41A1-BC76-3CA3F92E88B3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6CDB3-7D58-4CA6-B2B5-1DAC2CCCFA21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39542275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FC9961-3790-42AE-9302-1B23EE14A294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583DE47-652A-49D8-8C97-C7340DF6817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7038120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1B453DF-15FD-4D69-827B-E0A604D68BC1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24A82D-93B3-4882-878A-0FE807DBF71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1104817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C12C70E-B23C-4D90-879E-382F9141AD90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541C97-6916-40A5-886D-2C7C9B0D960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xmlns="" val="21404516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0FC134B-56EE-408D-8FF1-9CEBBBF3C3FB}" type="datetime1">
              <a:rPr lang="ja-JP" altLang="en-US" smtClean="0"/>
              <a:pPr>
                <a:defRPr/>
              </a:pPr>
              <a:t>2018/10/6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97255399-5B71-4E90-80F1-4322368DC9E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番号プレースホルダー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583DE47-652A-49D8-8C97-C7340DF68172}" type="slidenum">
              <a:rPr lang="ja-JP" altLang="en-US" smtClean="0"/>
              <a:pPr>
                <a:defRPr/>
              </a:pPr>
              <a:t>1</a:t>
            </a:fld>
            <a:endParaRPr lang="ja-JP" altLang="en-US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51520" y="3707645"/>
            <a:ext cx="8568952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SI1. The distributions of 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7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s activity concentrations in the North Pacific Ocean in August-December, 2012. The data measured during the period from August to December, 2012 were composited and decay corrected to (a) 1 October 2012, and (b) 11 March 2011. The circles are the measurement data. The unit of measurement is Bqm</a:t>
            </a:r>
            <a:r>
              <a:rPr lang="en-GB" altLang="ja-JP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3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ja-JP" altLang="ja-JP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kumimoji="1" lang="ja-JP" alt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-180528" y="22632"/>
            <a:ext cx="5025509" cy="3551589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4127659" y="22631"/>
            <a:ext cx="5025509" cy="3551589"/>
          </a:xfrm>
          <a:prstGeom prst="rect">
            <a:avLst/>
          </a:prstGeom>
        </p:spPr>
      </p:pic>
      <p:sp>
        <p:nvSpPr>
          <p:cNvPr id="8" name="テキスト ボックス 7"/>
          <p:cNvSpPr txBox="1"/>
          <p:nvPr/>
        </p:nvSpPr>
        <p:spPr>
          <a:xfrm>
            <a:off x="327540" y="733346"/>
            <a:ext cx="611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endParaRPr kumimoji="1" lang="ja-JP" alt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4234370" y="751417"/>
            <a:ext cx="6115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endParaRPr kumimoji="1" lang="ja-JP" altLang="en-US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66049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>
          <a:defRPr dirty="0" smtClean="0">
            <a:solidFill>
              <a:schemeClr val="tx2"/>
            </a:solidFill>
          </a:defRPr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8605</TotalTime>
  <Words>74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放射性物質の 海洋拡散シミュレーション</dc:title>
  <dc:creator>tsumune</dc:creator>
  <cp:lastModifiedBy>0003018</cp:lastModifiedBy>
  <cp:revision>916</cp:revision>
  <cp:lastPrinted>2018-07-29T07:57:04Z</cp:lastPrinted>
  <dcterms:created xsi:type="dcterms:W3CDTF">2011-04-07T05:25:28Z</dcterms:created>
  <dcterms:modified xsi:type="dcterms:W3CDTF">2018-10-06T10:27:51Z</dcterms:modified>
</cp:coreProperties>
</file>